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9" r:id="rId3"/>
    <p:sldId id="260" r:id="rId4"/>
    <p:sldId id="261" r:id="rId5"/>
    <p:sldId id="257" r:id="rId6"/>
    <p:sldId id="262" r:id="rId7"/>
    <p:sldId id="258" r:id="rId8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28" autoAdjust="0"/>
    <p:restoredTop sz="94793"/>
  </p:normalViewPr>
  <p:slideViewPr>
    <p:cSldViewPr snapToGrid="0" showGuides="1">
      <p:cViewPr>
        <p:scale>
          <a:sx n="90" d="100"/>
          <a:sy n="90" d="100"/>
        </p:scale>
        <p:origin x="104" y="4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B63AB5-958A-9A4D-81D9-D0C82E94C770}" type="datetimeFigureOut">
              <a:rPr lang="en-US" smtClean="0"/>
              <a:t>7/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385A29-47E3-704B-8CAB-5B40F7774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37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385A29-47E3-704B-8CAB-5B40F77742D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281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3773B2B-C29A-CB29-2C57-248571ACD6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20426C80-47CB-E392-DEA9-26C9618815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1A3EBBE-E912-3048-2E48-828B64B3D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FFDD6E3-92A7-4614-AF06-D15E33F30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48681466-B71C-42E3-F1BB-C8B720FC1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324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BE81B4F-41BB-60DE-D5F2-68D1F6954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6FE66687-1306-08EC-A546-67AAC7715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FDE2E74-D503-DC8A-D35A-7C6A8AAFD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45C33A2-680E-353F-B950-284BF67C9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B245CD9-A323-568F-2CDC-C383BFAD5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1946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196120D9-3FCB-8588-D9F8-FF97258621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6DEDFBB2-7AAB-6998-050C-A9285A2309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FFC0B5F-2BEF-7CE2-291C-3B79E344F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EA9361C-282C-1709-BEB3-7729EC574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8461AD7-A2DE-563A-39CA-D38A948D5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5979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7DFBCBA-14FB-5013-53F8-66FC5822D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56315577-A6CC-4090-46E9-1599E12AE7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B6C36FF-2E4E-1FE7-9ECF-553E5B4DE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DFC814E-9640-6825-61E2-D22F8C7E9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4B3D0CC-AD25-1AC2-0B1A-39D3E0E0D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24643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C2F42CC-6754-5193-AE15-0B75C2E05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9F4250AD-21E6-01AB-738F-9CA36654A7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2467221B-A123-DCBE-8DDA-484C32EA5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8221F48-C8C7-94F3-7347-4AEFB2843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C9216D9-2988-1E25-4FE2-D075498CE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25746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114FBCB-8EE1-DCC1-80C2-7F9883895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684DF24C-1FDF-52F7-6D9A-2DBB213E0C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C003EBCC-C3F4-C97E-2EA9-9F21D3C7B1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D4BFD80-BBB1-50BE-9737-A9459B37C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E83F001F-857E-9748-75EB-83CC5EA5E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134F646-56CF-A505-D2CD-43076C7F3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0042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F38D697-69B8-18F5-BD8B-A7419BEFC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41E21BC-A0FB-93F2-AF0C-4A3092E17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37A22128-F636-F6CA-D7B4-4330A114F4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53369CE6-ADDB-E2F8-35B3-24F1C70D6D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6FFA0DFD-81A7-BA26-7422-1761FEBDDC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8F215BB6-E5FB-63DB-E483-C08E318BC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1FEB792F-4CD7-7733-53F4-7C01BD0C0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0E71FEB5-E4E8-56B9-F7E2-A9BE481B7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3486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7BB134F-10BB-2620-F1C5-31BBE00DC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A51C8CFF-0D24-CC52-73B9-407FB056C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9FD59DA6-1250-9EC3-1390-C0B49101D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62204D0B-5DEE-0195-49A6-D482E4608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6205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CE878688-BAEF-357C-559C-4F5DC7A11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DB04EB1D-33DC-3B52-E329-ACD42971D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A7089DBF-F473-BB29-78E1-1962AF77D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0859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A7A179C-04D6-8DC7-25C0-AC9D05F352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9897816-6809-3646-3296-BDF87ADACD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359DE4F0-034F-A0DF-AE67-7FC43D6394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6046D1ED-2C14-F35D-FD5E-CE86E6B37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EF35C53-312B-B37D-4DA3-66F388011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17A93521-441F-60E6-9B88-E8E539416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95403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85F966E-6F6D-CC2C-7644-926A6AA75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C0AE8281-072C-7EFD-7453-0C0F03647A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C178BFCC-57FB-3EAB-E6BC-EBA5D05B56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E15F7F0-7493-DB3D-5764-58A2664A2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EC8BFD97-42CC-65E5-1775-136150B88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737E4D3-737C-FDDB-97A8-238CB34E4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39717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271783EA-A105-9C2B-D22C-AB2D3C001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207C8784-BA2E-6FB2-07A2-CCEA9B8982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E4361B3-D52C-C749-8966-4A1FFBF7BC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D8FFF5-9D23-419C-9C59-927D219432CA}" type="datetimeFigureOut">
              <a:rPr lang="zh-TW" altLang="en-US" smtClean="0"/>
              <a:t>2025/7/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CC7E16E-05E4-4CF4-6DD5-CC4EE1ACF8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8B721FA-3C45-FD06-8193-0896F03CA4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092BC4-6498-431F-A270-C861E90901F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4506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7" Type="http://schemas.openxmlformats.org/officeDocument/2006/relationships/image" Target="../media/image6.pn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群組 22">
            <a:extLst>
              <a:ext uri="{FF2B5EF4-FFF2-40B4-BE49-F238E27FC236}">
                <a16:creationId xmlns:a16="http://schemas.microsoft.com/office/drawing/2014/main" id="{F16B0E82-89EC-1924-0C08-2F55E10A7EF9}"/>
              </a:ext>
            </a:extLst>
          </p:cNvPr>
          <p:cNvGrpSpPr/>
          <p:nvPr/>
        </p:nvGrpSpPr>
        <p:grpSpPr>
          <a:xfrm>
            <a:off x="1953618" y="729000"/>
            <a:ext cx="7994567" cy="5400000"/>
            <a:chOff x="1953618" y="729000"/>
            <a:chExt cx="7994567" cy="5400000"/>
          </a:xfrm>
        </p:grpSpPr>
        <p:pic>
          <p:nvPicPr>
            <p:cNvPr id="4" name="圖片 3" descr="一張含有 黑與白, 螢幕擷取畫面, 黑色, 單色 的圖片&#10;&#10;AI 產生的內容可能不正確。">
              <a:extLst>
                <a:ext uri="{FF2B5EF4-FFF2-40B4-BE49-F238E27FC236}">
                  <a16:creationId xmlns:a16="http://schemas.microsoft.com/office/drawing/2014/main" id="{442A8FD3-B668-D70E-8EDE-66E28C12384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7" t="15778" r="6628" b="7628"/>
            <a:stretch/>
          </p:blipFill>
          <p:spPr>
            <a:xfrm>
              <a:off x="2243815" y="729000"/>
              <a:ext cx="7704370" cy="5400000"/>
            </a:xfrm>
            <a:prstGeom prst="rect">
              <a:avLst/>
            </a:prstGeom>
          </p:spPr>
        </p:pic>
        <p:sp>
          <p:nvSpPr>
            <p:cNvPr id="5" name="文字方塊 4">
              <a:extLst>
                <a:ext uri="{FF2B5EF4-FFF2-40B4-BE49-F238E27FC236}">
                  <a16:creationId xmlns:a16="http://schemas.microsoft.com/office/drawing/2014/main" id="{1CE93D0C-CBCC-EEEE-9542-F0D01A49B6B8}"/>
                </a:ext>
              </a:extLst>
            </p:cNvPr>
            <p:cNvSpPr txBox="1"/>
            <p:nvPr/>
          </p:nvSpPr>
          <p:spPr>
            <a:xfrm>
              <a:off x="2670421" y="1155465"/>
              <a:ext cx="1514927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D647E69D-120F-4375-72B4-6DE0C6F02711}"/>
                </a:ext>
              </a:extLst>
            </p:cNvPr>
            <p:cNvSpPr txBox="1"/>
            <p:nvPr/>
          </p:nvSpPr>
          <p:spPr>
            <a:xfrm>
              <a:off x="3344020" y="1155465"/>
              <a:ext cx="1418121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IUS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4B0FF206-085A-A3C5-97F6-1332334AC710}"/>
                </a:ext>
              </a:extLst>
            </p:cNvPr>
            <p:cNvSpPr txBox="1"/>
            <p:nvPr/>
          </p:nvSpPr>
          <p:spPr>
            <a:xfrm>
              <a:off x="3932890" y="1155465"/>
              <a:ext cx="1514927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D9D53C54-08D5-0FCA-A9F1-53CDCCFCD881}"/>
                </a:ext>
              </a:extLst>
            </p:cNvPr>
            <p:cNvSpPr txBox="1"/>
            <p:nvPr/>
          </p:nvSpPr>
          <p:spPr>
            <a:xfrm>
              <a:off x="4606489" y="1155465"/>
              <a:ext cx="1418121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IUS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E76E969A-2048-4D0A-44F2-9980C1DF0BD3}"/>
                </a:ext>
              </a:extLst>
            </p:cNvPr>
            <p:cNvSpPr txBox="1"/>
            <p:nvPr/>
          </p:nvSpPr>
          <p:spPr>
            <a:xfrm>
              <a:off x="5140917" y="1155465"/>
              <a:ext cx="1514927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B49944DD-9CBF-D951-D471-25166EA2CCA7}"/>
                </a:ext>
              </a:extLst>
            </p:cNvPr>
            <p:cNvSpPr txBox="1"/>
            <p:nvPr/>
          </p:nvSpPr>
          <p:spPr>
            <a:xfrm>
              <a:off x="5814516" y="1155465"/>
              <a:ext cx="1418121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IUS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5C8F38F3-D628-6668-C54A-12123BC65E8E}"/>
                </a:ext>
              </a:extLst>
            </p:cNvPr>
            <p:cNvSpPr txBox="1"/>
            <p:nvPr/>
          </p:nvSpPr>
          <p:spPr>
            <a:xfrm>
              <a:off x="6453991" y="1155465"/>
              <a:ext cx="1514927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1C5373C7-45A0-32C3-8BA2-2B92EBC9C856}"/>
                </a:ext>
              </a:extLst>
            </p:cNvPr>
            <p:cNvSpPr txBox="1"/>
            <p:nvPr/>
          </p:nvSpPr>
          <p:spPr>
            <a:xfrm>
              <a:off x="7127590" y="1155465"/>
              <a:ext cx="1418121" cy="479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</a:t>
              </a:r>
            </a:p>
            <a:p>
              <a:pPr algn="ctr"/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IUS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AF5FFC68-EF85-6E4B-56A3-0DC4FA1962D9}"/>
                </a:ext>
              </a:extLst>
            </p:cNvPr>
            <p:cNvSpPr txBox="1"/>
            <p:nvPr/>
          </p:nvSpPr>
          <p:spPr>
            <a:xfrm>
              <a:off x="1953618" y="2347376"/>
              <a:ext cx="12195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r>
                <a:rPr lang="zh-TW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12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zh-TW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E4673629-D206-4868-7339-A14B5AB8A52A}"/>
                </a:ext>
              </a:extLst>
            </p:cNvPr>
            <p:cNvSpPr txBox="1"/>
            <p:nvPr/>
          </p:nvSpPr>
          <p:spPr>
            <a:xfrm>
              <a:off x="4578176" y="3900361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i="1" dirty="0">
                  <a:solidFill>
                    <a:srgbClr val="FF0000"/>
                  </a:solidFill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NECTIN2</a:t>
              </a:r>
              <a:endParaRPr lang="zh-TW" altLang="en-US" sz="16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F0ED3BCE-6BD3-B861-62B2-523779F3452E}"/>
                </a:ext>
              </a:extLst>
            </p:cNvPr>
            <p:cNvSpPr txBox="1"/>
            <p:nvPr/>
          </p:nvSpPr>
          <p:spPr>
            <a:xfrm>
              <a:off x="5804522" y="3900361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i="1" dirty="0">
                  <a:solidFill>
                    <a:srgbClr val="FF0000"/>
                  </a:solidFill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TOMM40</a:t>
              </a:r>
              <a:endParaRPr lang="zh-TW" altLang="en-US" sz="16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31A1223A-6DFB-3B87-05F4-70F91D7CA44A}"/>
                </a:ext>
              </a:extLst>
            </p:cNvPr>
            <p:cNvSpPr txBox="1"/>
            <p:nvPr/>
          </p:nvSpPr>
          <p:spPr>
            <a:xfrm>
              <a:off x="3230269" y="3900361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TW" sz="1600" b="1" i="1" dirty="0">
                  <a:solidFill>
                    <a:srgbClr val="FF0000"/>
                  </a:solidFill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β</a:t>
              </a:r>
              <a:r>
                <a:rPr lang="en-US" altLang="zh-TW" sz="1600" b="1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TW" altLang="en-US" sz="16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37188699-440F-0F20-3C9F-9A159405EC56}"/>
                </a:ext>
              </a:extLst>
            </p:cNvPr>
            <p:cNvSpPr txBox="1"/>
            <p:nvPr/>
          </p:nvSpPr>
          <p:spPr>
            <a:xfrm>
              <a:off x="7132776" y="3900361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i="1" dirty="0">
                  <a:solidFill>
                    <a:srgbClr val="FF0000"/>
                  </a:solidFill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TNNT1</a:t>
              </a:r>
              <a:endParaRPr lang="zh-TW" altLang="en-US" sz="16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41770C50-9CF5-9035-4D79-F12CF42C0C32}"/>
                </a:ext>
              </a:extLst>
            </p:cNvPr>
            <p:cNvSpPr/>
            <p:nvPr/>
          </p:nvSpPr>
          <p:spPr>
            <a:xfrm>
              <a:off x="6894043" y="2545758"/>
              <a:ext cx="1184864" cy="47939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A9F8E48A-9430-40A4-9A6B-B4ABA5C20CDC}"/>
                </a:ext>
              </a:extLst>
            </p:cNvPr>
            <p:cNvSpPr/>
            <p:nvPr/>
          </p:nvSpPr>
          <p:spPr>
            <a:xfrm>
              <a:off x="4390671" y="2616533"/>
              <a:ext cx="1184864" cy="47939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E37D2C20-176C-7908-73A6-D6FBCFD80507}"/>
                </a:ext>
              </a:extLst>
            </p:cNvPr>
            <p:cNvSpPr/>
            <p:nvPr/>
          </p:nvSpPr>
          <p:spPr>
            <a:xfrm>
              <a:off x="5642357" y="2651749"/>
              <a:ext cx="1184864" cy="47939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D1C8FF62-C76C-58AF-B649-95AC26B67C07}"/>
                </a:ext>
              </a:extLst>
            </p:cNvPr>
            <p:cNvSpPr/>
            <p:nvPr/>
          </p:nvSpPr>
          <p:spPr>
            <a:xfrm>
              <a:off x="3171643" y="2197024"/>
              <a:ext cx="1184864" cy="47939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3799EA7F-2C13-0191-51A2-9F1B88E4F6D0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2E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0294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4705B3AB-3C5E-48C4-2D91-8E5D1E0A5D08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FDCED3A7-5A54-95DD-4DF1-871CCC19F47D}"/>
              </a:ext>
            </a:extLst>
          </p:cNvPr>
          <p:cNvGrpSpPr/>
          <p:nvPr/>
        </p:nvGrpSpPr>
        <p:grpSpPr>
          <a:xfrm>
            <a:off x="1225573" y="1123424"/>
            <a:ext cx="2289307" cy="4074307"/>
            <a:chOff x="646773" y="1033627"/>
            <a:chExt cx="2289307" cy="407430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EE9B5F8-D656-790D-4BF3-53DECB3872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6773" y="1322450"/>
              <a:ext cx="1212666" cy="3785484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01174729-4421-B371-4AD6-C609D849E41C}"/>
                </a:ext>
              </a:extLst>
            </p:cNvPr>
            <p:cNvSpPr/>
            <p:nvPr/>
          </p:nvSpPr>
          <p:spPr>
            <a:xfrm>
              <a:off x="1015740" y="1835216"/>
              <a:ext cx="773361" cy="34599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6C9E45D-1B1B-0C06-3FD8-B9731B60EA46}"/>
                </a:ext>
              </a:extLst>
            </p:cNvPr>
            <p:cNvSpPr txBox="1"/>
            <p:nvPr/>
          </p:nvSpPr>
          <p:spPr>
            <a:xfrm>
              <a:off x="989300" y="1033627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7C96F77-C859-325D-C4B6-87B4DABC8327}"/>
                </a:ext>
              </a:extLst>
            </p:cNvPr>
            <p:cNvSpPr txBox="1"/>
            <p:nvPr/>
          </p:nvSpPr>
          <p:spPr>
            <a:xfrm>
              <a:off x="1411595" y="1033627"/>
              <a:ext cx="4828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S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D94A99B-583C-424B-D54B-188C22FFDC36}"/>
                </a:ext>
              </a:extLst>
            </p:cNvPr>
            <p:cNvSpPr txBox="1"/>
            <p:nvPr/>
          </p:nvSpPr>
          <p:spPr>
            <a:xfrm>
              <a:off x="1859439" y="1811874"/>
              <a:ext cx="10766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RAD21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CA0DB5C-0EE3-C966-F914-11DFD82BC509}"/>
                </a:ext>
              </a:extLst>
            </p:cNvPr>
            <p:cNvSpPr/>
            <p:nvPr/>
          </p:nvSpPr>
          <p:spPr>
            <a:xfrm>
              <a:off x="1015740" y="2893203"/>
              <a:ext cx="773361" cy="34599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E073730-D4B5-E3B9-8473-94DE7FEFBCE0}"/>
                </a:ext>
              </a:extLst>
            </p:cNvPr>
            <p:cNvSpPr txBox="1"/>
            <p:nvPr/>
          </p:nvSpPr>
          <p:spPr>
            <a:xfrm>
              <a:off x="1859439" y="2881563"/>
              <a:ext cx="9362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GAPDH</a:t>
              </a:r>
            </a:p>
          </p:txBody>
        </p:sp>
      </p:grpSp>
      <p:sp>
        <p:nvSpPr>
          <p:cNvPr id="12" name="文字方塊 1">
            <a:extLst>
              <a:ext uri="{FF2B5EF4-FFF2-40B4-BE49-F238E27FC236}">
                <a16:creationId xmlns:a16="http://schemas.microsoft.com/office/drawing/2014/main" id="{7BF45AEF-FB19-539E-B872-91878836884C}"/>
              </a:ext>
            </a:extLst>
          </p:cNvPr>
          <p:cNvSpPr txBox="1"/>
          <p:nvPr/>
        </p:nvSpPr>
        <p:spPr>
          <a:xfrm>
            <a:off x="5325321" y="169532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oogle Shape;83;p17">
            <a:extLst>
              <a:ext uri="{FF2B5EF4-FFF2-40B4-BE49-F238E27FC236}">
                <a16:creationId xmlns:a16="http://schemas.microsoft.com/office/drawing/2014/main" id="{56841FDB-3848-7E24-49FA-F7F2AD912491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18698" r="69930" b="52963"/>
          <a:stretch>
            <a:fillRect/>
          </a:stretch>
        </p:blipFill>
        <p:spPr>
          <a:xfrm>
            <a:off x="5496573" y="1482065"/>
            <a:ext cx="1076641" cy="3643472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1BCDC56B-E879-3309-BB3E-DE0B56D0BDE0}"/>
              </a:ext>
            </a:extLst>
          </p:cNvPr>
          <p:cNvSpPr/>
          <p:nvPr/>
        </p:nvSpPr>
        <p:spPr>
          <a:xfrm>
            <a:off x="5729517" y="3446584"/>
            <a:ext cx="773361" cy="3459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DC59290-EE62-4013-6CCA-06B30EF74E44}"/>
              </a:ext>
            </a:extLst>
          </p:cNvPr>
          <p:cNvSpPr txBox="1"/>
          <p:nvPr/>
        </p:nvSpPr>
        <p:spPr>
          <a:xfrm>
            <a:off x="6448629" y="3411416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2A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6871FD3A-D656-D87E-E7D3-3BD26AD936E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8195" b="3921"/>
          <a:stretch>
            <a:fillRect/>
          </a:stretch>
        </p:blipFill>
        <p:spPr>
          <a:xfrm>
            <a:off x="7314572" y="1678393"/>
            <a:ext cx="1700429" cy="3232094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50BF3B70-EE6B-FD1D-BAB8-1BCCDB49DB98}"/>
              </a:ext>
            </a:extLst>
          </p:cNvPr>
          <p:cNvSpPr/>
          <p:nvPr/>
        </p:nvSpPr>
        <p:spPr>
          <a:xfrm>
            <a:off x="7861219" y="4099727"/>
            <a:ext cx="998559" cy="4467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7436039-85C6-7358-E5C3-762DE7267E21}"/>
              </a:ext>
            </a:extLst>
          </p:cNvPr>
          <p:cNvGrpSpPr/>
          <p:nvPr/>
        </p:nvGrpSpPr>
        <p:grpSpPr>
          <a:xfrm>
            <a:off x="9942381" y="2008211"/>
            <a:ext cx="1391037" cy="2820715"/>
            <a:chOff x="8328321" y="1996540"/>
            <a:chExt cx="1391037" cy="282071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F586E22-E1AD-BDE3-695E-05F77230D6F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8321" y="1996540"/>
              <a:ext cx="1391037" cy="2820715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637713A-AD22-EC44-BFA8-F82F283D35AF}"/>
                </a:ext>
              </a:extLst>
            </p:cNvPr>
            <p:cNvSpPr/>
            <p:nvPr/>
          </p:nvSpPr>
          <p:spPr>
            <a:xfrm>
              <a:off x="8720800" y="3773147"/>
              <a:ext cx="928298" cy="326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E4A3F00D-644F-1B3A-EADF-BE6EAA81FF54}"/>
              </a:ext>
            </a:extLst>
          </p:cNvPr>
          <p:cNvSpPr txBox="1"/>
          <p:nvPr/>
        </p:nvSpPr>
        <p:spPr>
          <a:xfrm>
            <a:off x="8890416" y="411776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2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8B76B3C-396C-A21D-F279-586703248D47}"/>
              </a:ext>
            </a:extLst>
          </p:cNvPr>
          <p:cNvSpPr txBox="1"/>
          <p:nvPr/>
        </p:nvSpPr>
        <p:spPr>
          <a:xfrm>
            <a:off x="11263158" y="3763442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3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F071C87-78BA-2365-C731-2C8785DC6BC5}"/>
              </a:ext>
            </a:extLst>
          </p:cNvPr>
          <p:cNvSpPr/>
          <p:nvPr/>
        </p:nvSpPr>
        <p:spPr>
          <a:xfrm>
            <a:off x="7846876" y="2869861"/>
            <a:ext cx="998559" cy="3023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3A0FAD2-DE9F-EA85-8266-C1DBE20BB663}"/>
              </a:ext>
            </a:extLst>
          </p:cNvPr>
          <p:cNvSpPr txBox="1"/>
          <p:nvPr/>
        </p:nvSpPr>
        <p:spPr>
          <a:xfrm>
            <a:off x="8849806" y="2791246"/>
            <a:ext cx="1171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Tubul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BE09AA1-4E12-D7CF-02F9-A869870DCCAF}"/>
              </a:ext>
            </a:extLst>
          </p:cNvPr>
          <p:cNvSpPr txBox="1"/>
          <p:nvPr/>
        </p:nvSpPr>
        <p:spPr>
          <a:xfrm>
            <a:off x="5723881" y="121829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D38E7E0-9EB4-C13F-A3B1-6A1104F0024A}"/>
              </a:ext>
            </a:extLst>
          </p:cNvPr>
          <p:cNvSpPr txBox="1"/>
          <p:nvPr/>
        </p:nvSpPr>
        <p:spPr>
          <a:xfrm>
            <a:off x="6146176" y="1218293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64DC420-1AA8-BB9C-F412-6AFF846D3400}"/>
              </a:ext>
            </a:extLst>
          </p:cNvPr>
          <p:cNvSpPr txBox="1"/>
          <p:nvPr/>
        </p:nvSpPr>
        <p:spPr>
          <a:xfrm>
            <a:off x="7768310" y="129739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E47D82E-5379-D088-D93A-60E573F06695}"/>
              </a:ext>
            </a:extLst>
          </p:cNvPr>
          <p:cNvSpPr txBox="1"/>
          <p:nvPr/>
        </p:nvSpPr>
        <p:spPr>
          <a:xfrm>
            <a:off x="8190605" y="1297399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1839EA-F77C-DFDA-5D86-F9439D36B601}"/>
              </a:ext>
            </a:extLst>
          </p:cNvPr>
          <p:cNvSpPr txBox="1"/>
          <p:nvPr/>
        </p:nvSpPr>
        <p:spPr>
          <a:xfrm>
            <a:off x="10257582" y="2181206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AB346A0-BD0B-F632-983C-17DF5F755E50}"/>
              </a:ext>
            </a:extLst>
          </p:cNvPr>
          <p:cNvSpPr txBox="1"/>
          <p:nvPr/>
        </p:nvSpPr>
        <p:spPr>
          <a:xfrm>
            <a:off x="10679877" y="2181206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75C7C55-6020-1B7F-C008-6F88ED7099A4}"/>
              </a:ext>
            </a:extLst>
          </p:cNvPr>
          <p:cNvSpPr txBox="1"/>
          <p:nvPr/>
        </p:nvSpPr>
        <p:spPr>
          <a:xfrm>
            <a:off x="11088810" y="2802908"/>
            <a:ext cx="1171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⍺- Tubulin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30740AD1-C764-C5D2-270E-8DDC488AA32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73" r="28967"/>
          <a:stretch>
            <a:fillRect/>
          </a:stretch>
        </p:blipFill>
        <p:spPr>
          <a:xfrm>
            <a:off x="-7482" y="1380218"/>
            <a:ext cx="1142096" cy="40767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B8B4AAA-1262-F8E5-7B60-10183735C6D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0647" y="1492756"/>
            <a:ext cx="919369" cy="3677476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BADB524-BCF5-7AD2-6C3A-4C9E608F0F97}"/>
              </a:ext>
            </a:extLst>
          </p:cNvPr>
          <p:cNvSpPr txBox="1"/>
          <p:nvPr/>
        </p:nvSpPr>
        <p:spPr>
          <a:xfrm>
            <a:off x="3605627" y="119555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C84027E-1799-2E74-CCE2-E2EFE6F9D9C8}"/>
              </a:ext>
            </a:extLst>
          </p:cNvPr>
          <p:cNvSpPr txBox="1"/>
          <p:nvPr/>
        </p:nvSpPr>
        <p:spPr>
          <a:xfrm>
            <a:off x="3969773" y="1185120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EE0BA6A-8C1F-65D4-3EFF-1A605FEDD106}"/>
              </a:ext>
            </a:extLst>
          </p:cNvPr>
          <p:cNvSpPr/>
          <p:nvPr/>
        </p:nvSpPr>
        <p:spPr>
          <a:xfrm>
            <a:off x="3786069" y="2433362"/>
            <a:ext cx="574334" cy="2418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24E5ABD-CF0C-007F-716B-8CEA41577F72}"/>
              </a:ext>
            </a:extLst>
          </p:cNvPr>
          <p:cNvSpPr txBox="1"/>
          <p:nvPr/>
        </p:nvSpPr>
        <p:spPr>
          <a:xfrm>
            <a:off x="4372245" y="2324168"/>
            <a:ext cx="9850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CTCF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F493C56-B6AC-6BC3-8C3D-93A2014531EF}"/>
              </a:ext>
            </a:extLst>
          </p:cNvPr>
          <p:cNvSpPr txBox="1"/>
          <p:nvPr/>
        </p:nvSpPr>
        <p:spPr>
          <a:xfrm>
            <a:off x="4426325" y="3366561"/>
            <a:ext cx="1112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⍺-Tubuli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12DCA9A-F721-4C1C-1075-73134F8F9F1C}"/>
              </a:ext>
            </a:extLst>
          </p:cNvPr>
          <p:cNvSpPr txBox="1"/>
          <p:nvPr/>
        </p:nvSpPr>
        <p:spPr>
          <a:xfrm>
            <a:off x="4433882" y="3895553"/>
            <a:ext cx="114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⍺-GAPDH</a:t>
            </a:r>
          </a:p>
        </p:txBody>
      </p:sp>
    </p:spTree>
    <p:extLst>
      <p:ext uri="{BB962C8B-B14F-4D97-AF65-F5344CB8AC3E}">
        <p14:creationId xmlns:p14="http://schemas.microsoft.com/office/powerpoint/2010/main" val="2183556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7285E16B-D9FE-877F-A1CC-290C7627AF0D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EA85A00-CFF7-5C7E-B726-0B4ED57FB8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49" y="1228272"/>
            <a:ext cx="1746066" cy="442042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6886A1C-2D92-E8DD-692F-1A156492100B}"/>
              </a:ext>
            </a:extLst>
          </p:cNvPr>
          <p:cNvSpPr/>
          <p:nvPr/>
        </p:nvSpPr>
        <p:spPr>
          <a:xfrm>
            <a:off x="1119505" y="2991742"/>
            <a:ext cx="758282" cy="4467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BE0F8F8-A052-7C95-71AA-B8D630973F4D}"/>
              </a:ext>
            </a:extLst>
          </p:cNvPr>
          <p:cNvSpPr txBox="1"/>
          <p:nvPr/>
        </p:nvSpPr>
        <p:spPr>
          <a:xfrm>
            <a:off x="1064155" y="684122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3D15D37-1836-D4F0-ACCB-59D2137DD8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6285" y="1228271"/>
            <a:ext cx="1456872" cy="4621801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66816BC7-0965-FF2A-406E-1D4D8FA69344}"/>
              </a:ext>
            </a:extLst>
          </p:cNvPr>
          <p:cNvSpPr/>
          <p:nvPr/>
        </p:nvSpPr>
        <p:spPr>
          <a:xfrm>
            <a:off x="2980433" y="2856853"/>
            <a:ext cx="998559" cy="4467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50C466-E8F5-2225-2A46-A30CA74CF61B}"/>
              </a:ext>
            </a:extLst>
          </p:cNvPr>
          <p:cNvSpPr txBox="1"/>
          <p:nvPr/>
        </p:nvSpPr>
        <p:spPr>
          <a:xfrm>
            <a:off x="2515789" y="638596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3K9me2/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5DE14B8-0D10-DC58-90A6-4F6F9B573AD4}"/>
              </a:ext>
            </a:extLst>
          </p:cNvPr>
          <p:cNvSpPr txBox="1"/>
          <p:nvPr/>
        </p:nvSpPr>
        <p:spPr>
          <a:xfrm>
            <a:off x="968408" y="104360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197C51-5285-CB2F-8ED1-44B19ED0BE82}"/>
              </a:ext>
            </a:extLst>
          </p:cNvPr>
          <p:cNvSpPr txBox="1"/>
          <p:nvPr/>
        </p:nvSpPr>
        <p:spPr>
          <a:xfrm>
            <a:off x="1390703" y="1043605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F95292B-59D8-ECF1-FCBE-E71168B170DB}"/>
              </a:ext>
            </a:extLst>
          </p:cNvPr>
          <p:cNvSpPr txBox="1"/>
          <p:nvPr/>
        </p:nvSpPr>
        <p:spPr>
          <a:xfrm>
            <a:off x="2897768" y="99030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4E3A5A-D95F-5185-C6C6-2F78EAB145E0}"/>
              </a:ext>
            </a:extLst>
          </p:cNvPr>
          <p:cNvSpPr txBox="1"/>
          <p:nvPr/>
        </p:nvSpPr>
        <p:spPr>
          <a:xfrm>
            <a:off x="3320063" y="990301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S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9268817C-09FB-CC9D-EA33-F724B4EDFBD1}"/>
              </a:ext>
            </a:extLst>
          </p:cNvPr>
          <p:cNvGrpSpPr/>
          <p:nvPr/>
        </p:nvGrpSpPr>
        <p:grpSpPr>
          <a:xfrm>
            <a:off x="8250991" y="715309"/>
            <a:ext cx="2713306" cy="5009922"/>
            <a:chOff x="8924767" y="715309"/>
            <a:chExt cx="2713306" cy="5009922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A5F9DA1-F5C6-98D2-8F0F-D87067411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24767" y="1228271"/>
              <a:ext cx="2008642" cy="4496960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209E5E8-8A16-B4EF-86E1-259CFA7241AF}"/>
                </a:ext>
              </a:extLst>
            </p:cNvPr>
            <p:cNvSpPr/>
            <p:nvPr/>
          </p:nvSpPr>
          <p:spPr>
            <a:xfrm>
              <a:off x="9601097" y="3449555"/>
              <a:ext cx="998559" cy="44674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74C80A0-1B6C-D9E1-3ED3-FE5CD30671FD}"/>
                </a:ext>
              </a:extLst>
            </p:cNvPr>
            <p:cNvSpPr txBox="1"/>
            <p:nvPr/>
          </p:nvSpPr>
          <p:spPr>
            <a:xfrm>
              <a:off x="9164861" y="715309"/>
              <a:ext cx="1353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 H3K27ac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096D0FB-520E-656E-0890-8125187E9C73}"/>
                </a:ext>
              </a:extLst>
            </p:cNvPr>
            <p:cNvSpPr txBox="1"/>
            <p:nvPr/>
          </p:nvSpPr>
          <p:spPr>
            <a:xfrm>
              <a:off x="10466085" y="2140649"/>
              <a:ext cx="11719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⍺- Tubuli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297D88F-59FF-66C9-A7A3-8C783BA45C2D}"/>
                </a:ext>
              </a:extLst>
            </p:cNvPr>
            <p:cNvSpPr txBox="1"/>
            <p:nvPr/>
          </p:nvSpPr>
          <p:spPr>
            <a:xfrm>
              <a:off x="9419194" y="1037954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F11B444-2CD2-E8A6-4C87-A75E1A1040C0}"/>
                </a:ext>
              </a:extLst>
            </p:cNvPr>
            <p:cNvSpPr txBox="1"/>
            <p:nvPr/>
          </p:nvSpPr>
          <p:spPr>
            <a:xfrm>
              <a:off x="9841489" y="1037954"/>
              <a:ext cx="4828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S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21C56076-C580-51BF-3F3E-5F8E3B122351}"/>
              </a:ext>
            </a:extLst>
          </p:cNvPr>
          <p:cNvGrpSpPr/>
          <p:nvPr/>
        </p:nvGrpSpPr>
        <p:grpSpPr>
          <a:xfrm>
            <a:off x="4329488" y="919460"/>
            <a:ext cx="1302113" cy="5329801"/>
            <a:chOff x="8383728" y="853288"/>
            <a:chExt cx="1302113" cy="5329801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CB8297F5-408B-4A9B-61C7-4EDF0476835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3728" y="1174966"/>
              <a:ext cx="1302112" cy="5008123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A925255-4AA9-45CE-DF46-A1D72CCF9E37}"/>
                </a:ext>
              </a:extLst>
            </p:cNvPr>
            <p:cNvSpPr/>
            <p:nvPr/>
          </p:nvSpPr>
          <p:spPr>
            <a:xfrm>
              <a:off x="8829425" y="3440439"/>
              <a:ext cx="856416" cy="369332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38BA1AB-A1DF-20BD-C8AA-1AA481C5915B}"/>
                </a:ext>
              </a:extLst>
            </p:cNvPr>
            <p:cNvSpPr txBox="1"/>
            <p:nvPr/>
          </p:nvSpPr>
          <p:spPr>
            <a:xfrm>
              <a:off x="8716719" y="853288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B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44703D6-2149-2677-F9C5-8C35A8AD23FD}"/>
                </a:ext>
              </a:extLst>
            </p:cNvPr>
            <p:cNvSpPr txBox="1"/>
            <p:nvPr/>
          </p:nvSpPr>
          <p:spPr>
            <a:xfrm>
              <a:off x="9139014" y="853288"/>
              <a:ext cx="4828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S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C88271DD-CF22-6E4E-C3D1-5273AFEB4250}"/>
              </a:ext>
            </a:extLst>
          </p:cNvPr>
          <p:cNvSpPr txBox="1"/>
          <p:nvPr/>
        </p:nvSpPr>
        <p:spPr>
          <a:xfrm>
            <a:off x="4225182" y="628689"/>
            <a:ext cx="1550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 H3K27me3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527D1A5-CEA1-1909-7574-73D83B8CB8F2}"/>
              </a:ext>
            </a:extLst>
          </p:cNvPr>
          <p:cNvGrpSpPr/>
          <p:nvPr/>
        </p:nvGrpSpPr>
        <p:grpSpPr>
          <a:xfrm>
            <a:off x="5810796" y="640315"/>
            <a:ext cx="2380627" cy="5608946"/>
            <a:chOff x="5714540" y="640315"/>
            <a:chExt cx="2380627" cy="5608946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BC11CE2-7FCA-D8A9-D7AB-A9F2120D3608}"/>
                </a:ext>
              </a:extLst>
            </p:cNvPr>
            <p:cNvSpPr txBox="1"/>
            <p:nvPr/>
          </p:nvSpPr>
          <p:spPr>
            <a:xfrm>
              <a:off x="5714540" y="640315"/>
              <a:ext cx="1426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 H3K4me2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138596E7-C3A2-1465-1F04-911914859877}"/>
                </a:ext>
              </a:extLst>
            </p:cNvPr>
            <p:cNvGrpSpPr/>
            <p:nvPr/>
          </p:nvGrpSpPr>
          <p:grpSpPr>
            <a:xfrm>
              <a:off x="5885933" y="948103"/>
              <a:ext cx="2209234" cy="5301158"/>
              <a:chOff x="5885933" y="948103"/>
              <a:chExt cx="2209234" cy="5301158"/>
            </a:xfrm>
          </p:grpSpPr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3F5108B1-D971-5AFD-CFC1-B27B1CD8C1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85933" y="1206207"/>
                <a:ext cx="1183574" cy="5043054"/>
              </a:xfrm>
              <a:prstGeom prst="rect">
                <a:avLst/>
              </a:prstGeom>
            </p:spPr>
          </p:pic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3CE682CA-F20D-84CA-E959-A1F114ACF6A7}"/>
                  </a:ext>
                </a:extLst>
              </p:cNvPr>
              <p:cNvSpPr/>
              <p:nvPr/>
            </p:nvSpPr>
            <p:spPr>
              <a:xfrm>
                <a:off x="6137215" y="2710891"/>
                <a:ext cx="856416" cy="369332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D98A4F5-F448-17E7-B8EE-D746515B46D3}"/>
                  </a:ext>
                </a:extLst>
              </p:cNvPr>
              <p:cNvSpPr txBox="1"/>
              <p:nvPr/>
            </p:nvSpPr>
            <p:spPr>
              <a:xfrm>
                <a:off x="6126091" y="948103"/>
                <a:ext cx="4924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OB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35C33D7-BF39-E587-F38E-B2286DB15601}"/>
                  </a:ext>
                </a:extLst>
              </p:cNvPr>
              <p:cNvSpPr txBox="1"/>
              <p:nvPr/>
            </p:nvSpPr>
            <p:spPr>
              <a:xfrm>
                <a:off x="6548386" y="948103"/>
                <a:ext cx="4828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OS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2589F71-85D0-C27D-B466-80DB12D40908}"/>
                  </a:ext>
                </a:extLst>
              </p:cNvPr>
              <p:cNvSpPr txBox="1"/>
              <p:nvPr/>
            </p:nvSpPr>
            <p:spPr>
              <a:xfrm>
                <a:off x="6900866" y="2032798"/>
                <a:ext cx="11943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⍺- GAPDH</a:t>
                </a:r>
              </a:p>
            </p:txBody>
          </p:sp>
        </p:grp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E01BBFA3-A09B-811C-73C3-B5133A60098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36" r="23794"/>
          <a:stretch>
            <a:fillRect/>
          </a:stretch>
        </p:blipFill>
        <p:spPr>
          <a:xfrm>
            <a:off x="10928518" y="1468261"/>
            <a:ext cx="1263482" cy="407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7869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454447AC-304F-01A4-D743-F016E1872B08}"/>
              </a:ext>
            </a:extLst>
          </p:cNvPr>
          <p:cNvSpPr txBox="1"/>
          <p:nvPr/>
        </p:nvSpPr>
        <p:spPr>
          <a:xfrm>
            <a:off x="637449" y="265654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400A7A9-1BE1-EB59-B84B-38B4A3B2CF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091" y="1579292"/>
            <a:ext cx="3052808" cy="444452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960A2B0-6CD0-CD19-9959-DF4B1F745EB4}"/>
              </a:ext>
            </a:extLst>
          </p:cNvPr>
          <p:cNvSpPr/>
          <p:nvPr/>
        </p:nvSpPr>
        <p:spPr>
          <a:xfrm>
            <a:off x="3013898" y="2160428"/>
            <a:ext cx="2249058" cy="4467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EC84991-54C6-56FB-886E-6E1BBA2F9920}"/>
              </a:ext>
            </a:extLst>
          </p:cNvPr>
          <p:cNvSpPr txBox="1"/>
          <p:nvPr/>
        </p:nvSpPr>
        <p:spPr>
          <a:xfrm>
            <a:off x="5262956" y="2383798"/>
            <a:ext cx="1076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RAD2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0F3EE4-E762-FC2F-7EDD-ECAAD097B850}"/>
              </a:ext>
            </a:extLst>
          </p:cNvPr>
          <p:cNvSpPr txBox="1"/>
          <p:nvPr/>
        </p:nvSpPr>
        <p:spPr>
          <a:xfrm>
            <a:off x="5262956" y="2124509"/>
            <a:ext cx="938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CTCF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77537A0-1E1A-B168-FF40-6E369EA06455}"/>
              </a:ext>
            </a:extLst>
          </p:cNvPr>
          <p:cNvSpPr/>
          <p:nvPr/>
        </p:nvSpPr>
        <p:spPr>
          <a:xfrm>
            <a:off x="3064675" y="3594753"/>
            <a:ext cx="2249058" cy="4467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39CDCF-0A0C-CA9F-121E-EEEED15BF370}"/>
              </a:ext>
            </a:extLst>
          </p:cNvPr>
          <p:cNvSpPr txBox="1"/>
          <p:nvPr/>
        </p:nvSpPr>
        <p:spPr>
          <a:xfrm>
            <a:off x="5280395" y="3575188"/>
            <a:ext cx="114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⍺-GAPD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60C43B-5436-25D7-470B-61AB7E6D7187}"/>
              </a:ext>
            </a:extLst>
          </p:cNvPr>
          <p:cNvSpPr txBox="1"/>
          <p:nvPr/>
        </p:nvSpPr>
        <p:spPr>
          <a:xfrm rot="18900000">
            <a:off x="2948013" y="1328827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8EBE7B-491D-1ED9-EC97-858E5A8EAF39}"/>
              </a:ext>
            </a:extLst>
          </p:cNvPr>
          <p:cNvSpPr txBox="1"/>
          <p:nvPr/>
        </p:nvSpPr>
        <p:spPr>
          <a:xfrm rot="18900000">
            <a:off x="3351889" y="1280347"/>
            <a:ext cx="745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iCtrl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2678F68-8483-B587-B052-1D927098BB7B}"/>
              </a:ext>
            </a:extLst>
          </p:cNvPr>
          <p:cNvSpPr txBox="1"/>
          <p:nvPr/>
        </p:nvSpPr>
        <p:spPr>
          <a:xfrm rot="18900000">
            <a:off x="4162113" y="1242560"/>
            <a:ext cx="1076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RAD2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AD1C2F-D550-1AC0-2D88-A6E0FEBE8BC5}"/>
              </a:ext>
            </a:extLst>
          </p:cNvPr>
          <p:cNvSpPr txBox="1"/>
          <p:nvPr/>
        </p:nvSpPr>
        <p:spPr>
          <a:xfrm rot="18900000">
            <a:off x="3711789" y="1208263"/>
            <a:ext cx="979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iCTCF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C32136-F0FA-C3DB-6501-B183935DB16E}"/>
              </a:ext>
            </a:extLst>
          </p:cNvPr>
          <p:cNvSpPr txBox="1"/>
          <p:nvPr/>
        </p:nvSpPr>
        <p:spPr>
          <a:xfrm rot="18900000">
            <a:off x="4841816" y="1078854"/>
            <a:ext cx="10766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RAD21 + </a:t>
            </a:r>
            <a:r>
              <a:rPr lang="en-US" dirty="0" err="1"/>
              <a:t>siCTCF</a:t>
            </a:r>
            <a:endParaRPr lang="en-US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CCFFD22F-9DD8-2607-C989-80E60DE7843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53" y="1763206"/>
            <a:ext cx="2019300" cy="40767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1FA0435-21FE-6D0A-1921-F8B4D6487D17}"/>
              </a:ext>
            </a:extLst>
          </p:cNvPr>
          <p:cNvSpPr txBox="1"/>
          <p:nvPr/>
        </p:nvSpPr>
        <p:spPr>
          <a:xfrm>
            <a:off x="5280395" y="3059668"/>
            <a:ext cx="1112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⍺-Tubulin</a:t>
            </a:r>
          </a:p>
        </p:txBody>
      </p:sp>
    </p:spTree>
    <p:extLst>
      <p:ext uri="{BB962C8B-B14F-4D97-AF65-F5344CB8AC3E}">
        <p14:creationId xmlns:p14="http://schemas.microsoft.com/office/powerpoint/2010/main" val="29285987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04505C44-B796-15E4-7D83-DF58762ABA09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圖片 24" descr="一張含有 文字, 螢幕擷取畫面, 圖書, Rectangle 的圖片&#10;&#10;AI 產生的內容可能不正確。">
            <a:extLst>
              <a:ext uri="{FF2B5EF4-FFF2-40B4-BE49-F238E27FC236}">
                <a16:creationId xmlns:a16="http://schemas.microsoft.com/office/drawing/2014/main" id="{47D73F03-A4BB-7227-8406-6F0F7BD5AB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4373" y="981495"/>
            <a:ext cx="5965767" cy="5134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510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495618E8-5AEA-9765-9812-188C94B32CBD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1519C0A-3B55-E72C-76C5-A90E98BC928B}"/>
              </a:ext>
            </a:extLst>
          </p:cNvPr>
          <p:cNvGrpSpPr/>
          <p:nvPr/>
        </p:nvGrpSpPr>
        <p:grpSpPr>
          <a:xfrm>
            <a:off x="2117430" y="1099306"/>
            <a:ext cx="3913926" cy="5328503"/>
            <a:chOff x="856526" y="1039148"/>
            <a:chExt cx="3913926" cy="532850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9D15ADD-5B29-EE5D-3188-F9F1D216BD4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6526" y="1039148"/>
              <a:ext cx="2374659" cy="5328503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CB6243ED-AFE3-C724-C3D4-CBE18C654A5B}"/>
                </a:ext>
              </a:extLst>
            </p:cNvPr>
            <p:cNvSpPr/>
            <p:nvPr/>
          </p:nvSpPr>
          <p:spPr>
            <a:xfrm>
              <a:off x="1145894" y="2093358"/>
              <a:ext cx="2085291" cy="20062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1426A8-B6AE-DD14-9E28-2EAE16F932CD}"/>
                </a:ext>
              </a:extLst>
            </p:cNvPr>
            <p:cNvSpPr/>
            <p:nvPr/>
          </p:nvSpPr>
          <p:spPr>
            <a:xfrm>
              <a:off x="1145894" y="2313595"/>
              <a:ext cx="2085291" cy="2586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3D69F6B-76BC-15E2-CB53-B0BF7582B80A}"/>
                </a:ext>
              </a:extLst>
            </p:cNvPr>
            <p:cNvSpPr/>
            <p:nvPr/>
          </p:nvSpPr>
          <p:spPr>
            <a:xfrm>
              <a:off x="1195574" y="3273726"/>
              <a:ext cx="2035611" cy="34670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AB0B9B1-3467-018F-FC1F-CF010AF53F70}"/>
                </a:ext>
              </a:extLst>
            </p:cNvPr>
            <p:cNvSpPr txBox="1"/>
            <p:nvPr/>
          </p:nvSpPr>
          <p:spPr>
            <a:xfrm>
              <a:off x="3231185" y="2009006"/>
              <a:ext cx="11719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 Tubuli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B96CFE-A401-F16C-2DD2-6D88E053DA34}"/>
                </a:ext>
              </a:extLst>
            </p:cNvPr>
            <p:cNvSpPr txBox="1"/>
            <p:nvPr/>
          </p:nvSpPr>
          <p:spPr>
            <a:xfrm>
              <a:off x="3220028" y="2307860"/>
              <a:ext cx="11943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 GAPD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4B32C00-6BA5-AA8B-9EA7-76762F4AF71F}"/>
                </a:ext>
              </a:extLst>
            </p:cNvPr>
            <p:cNvSpPr txBox="1"/>
            <p:nvPr/>
          </p:nvSpPr>
          <p:spPr>
            <a:xfrm>
              <a:off x="3220028" y="3244334"/>
              <a:ext cx="15504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⍺- H3K27me3</a:t>
              </a:r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70A8A0D5-BADA-26FF-ED83-442751AA48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130" y="1390650"/>
            <a:ext cx="2019300" cy="40767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D17893C-0BE3-CEE6-7336-CF9798F6056E}"/>
              </a:ext>
            </a:extLst>
          </p:cNvPr>
          <p:cNvSpPr txBox="1"/>
          <p:nvPr/>
        </p:nvSpPr>
        <p:spPr>
          <a:xfrm>
            <a:off x="2456478" y="729974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59D8E54-9CB1-1424-DC51-D3503B0D2E80}"/>
              </a:ext>
            </a:extLst>
          </p:cNvPr>
          <p:cNvSpPr txBox="1"/>
          <p:nvPr/>
        </p:nvSpPr>
        <p:spPr>
          <a:xfrm>
            <a:off x="2853521" y="710103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E2B9099-2532-A360-803E-FAB36BBD92D8}"/>
              </a:ext>
            </a:extLst>
          </p:cNvPr>
          <p:cNvSpPr txBox="1"/>
          <p:nvPr/>
        </p:nvSpPr>
        <p:spPr>
          <a:xfrm>
            <a:off x="3295788" y="710103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593D0C0-D3C9-5D76-93D2-71A1BD1ADB55}"/>
              </a:ext>
            </a:extLst>
          </p:cNvPr>
          <p:cNvSpPr txBox="1"/>
          <p:nvPr/>
        </p:nvSpPr>
        <p:spPr>
          <a:xfrm>
            <a:off x="4465753" y="-244584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C2373C-79AD-4E0F-D3D4-DF51C0855B74}"/>
              </a:ext>
            </a:extLst>
          </p:cNvPr>
          <p:cNvSpPr txBox="1"/>
          <p:nvPr/>
        </p:nvSpPr>
        <p:spPr>
          <a:xfrm>
            <a:off x="3692831" y="709578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C79612-BB60-8431-7140-1BFE7EDD705C}"/>
              </a:ext>
            </a:extLst>
          </p:cNvPr>
          <p:cNvSpPr txBox="1"/>
          <p:nvPr/>
        </p:nvSpPr>
        <p:spPr>
          <a:xfrm>
            <a:off x="4061800" y="729974"/>
            <a:ext cx="607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3BE2A5-8ED1-EAF9-A2DF-D11FCE499BE6}"/>
              </a:ext>
            </a:extLst>
          </p:cNvPr>
          <p:cNvSpPr txBox="1"/>
          <p:nvPr/>
        </p:nvSpPr>
        <p:spPr>
          <a:xfrm>
            <a:off x="6371862" y="1860940"/>
            <a:ext cx="470922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– Wild Type</a:t>
            </a:r>
          </a:p>
          <a:p>
            <a:r>
              <a:rPr lang="en-US" dirty="0"/>
              <a:t>2 – DMSO</a:t>
            </a:r>
          </a:p>
          <a:p>
            <a:r>
              <a:rPr lang="en-US" dirty="0"/>
              <a:t>3 – 3 µM EPZ005687 Treatment for 8 days</a:t>
            </a:r>
          </a:p>
          <a:p>
            <a:r>
              <a:rPr lang="en-US" dirty="0"/>
              <a:t>4 – 4 µM EPZ005687 Treatment for 8 days</a:t>
            </a:r>
          </a:p>
          <a:p>
            <a:r>
              <a:rPr lang="en-US" dirty="0"/>
              <a:t>5 – 5 µM EPZ005687 Treatment for 8 days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90607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D84E4A60-B448-6DE8-9C9B-37F0F12A12E7}"/>
              </a:ext>
            </a:extLst>
          </p:cNvPr>
          <p:cNvSpPr txBox="1"/>
          <p:nvPr/>
        </p:nvSpPr>
        <p:spPr>
          <a:xfrm>
            <a:off x="758283" y="172689"/>
            <a:ext cx="1485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6F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圖片 3" descr="一張含有 文字, 螢幕擷取畫面, 設計 的圖片&#10;&#10;AI 產生的內容可能不正確。">
            <a:extLst>
              <a:ext uri="{FF2B5EF4-FFF2-40B4-BE49-F238E27FC236}">
                <a16:creationId xmlns:a16="http://schemas.microsoft.com/office/drawing/2014/main" id="{5112232A-A4AC-DFF2-B387-EE458BF87F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3815" y="1124702"/>
            <a:ext cx="8474553" cy="4337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8463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6</TotalTime>
  <Words>177</Words>
  <Application>Microsoft Macintosh PowerPoint</Application>
  <PresentationFormat>Widescreen</PresentationFormat>
  <Paragraphs>90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Office 佈景主題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e, Siou-Luan</dc:creator>
  <cp:lastModifiedBy>LiChun Tu</cp:lastModifiedBy>
  <cp:revision>26</cp:revision>
  <dcterms:created xsi:type="dcterms:W3CDTF">2025-07-02T17:40:18Z</dcterms:created>
  <dcterms:modified xsi:type="dcterms:W3CDTF">2025-07-07T14:14:37Z</dcterms:modified>
</cp:coreProperties>
</file>